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57" r:id="rId3"/>
    <p:sldId id="264" r:id="rId4"/>
    <p:sldId id="266" r:id="rId5"/>
    <p:sldId id="268" r:id="rId6"/>
    <p:sldId id="270" r:id="rId7"/>
    <p:sldId id="258" r:id="rId8"/>
    <p:sldId id="279" r:id="rId9"/>
    <p:sldId id="269" r:id="rId10"/>
    <p:sldId id="280" r:id="rId11"/>
    <p:sldId id="281" r:id="rId12"/>
    <p:sldId id="263" r:id="rId13"/>
    <p:sldId id="272" r:id="rId14"/>
    <p:sldId id="273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53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066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40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886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234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85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860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674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634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1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955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05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74252-B4A6-4E31-8AA3-CDEE2832A646}" type="datetimeFigureOut">
              <a:rPr lang="en-US" smtClean="0"/>
              <a:t>9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EAB8F-F295-485C-A47F-250B33201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597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5997906" y="332643"/>
            <a:ext cx="17124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APDH, 37k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610197" y="863245"/>
            <a:ext cx="40732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A1   A2    A3     A4    A5    A6    N1    N2    N3   N4    N5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610196" y="3954573"/>
            <a:ext cx="41312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A7    A8    A9   A10  A11  N6   N7    N8    N9   N10    N11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227361"/>
              </p:ext>
            </p:extLst>
          </p:nvPr>
        </p:nvGraphicFramePr>
        <p:xfrm>
          <a:off x="8237913" y="863245"/>
          <a:ext cx="2626822" cy="524493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14443">
                  <a:extLst>
                    <a:ext uri="{9D8B030D-6E8A-4147-A177-3AD203B41FA5}">
                      <a16:colId xmlns:a16="http://schemas.microsoft.com/office/drawing/2014/main" val="4230382381"/>
                    </a:ext>
                  </a:extLst>
                </a:gridCol>
                <a:gridCol w="1212379">
                  <a:extLst>
                    <a:ext uri="{9D8B030D-6E8A-4147-A177-3AD203B41FA5}">
                      <a16:colId xmlns:a16="http://schemas.microsoft.com/office/drawing/2014/main" val="3886067288"/>
                    </a:ext>
                  </a:extLst>
                </a:gridCol>
              </a:tblGrid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Sample 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ID on ge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888271737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104164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2689315341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110514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2425258329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080614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1023221293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073113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810619490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573583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4181144729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091710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A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849776301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501417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N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4200800306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81844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N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556813957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82614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N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2212760709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0855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N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916072922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829747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4179728458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81114441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7071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662615477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7111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015539069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62410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895932267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473943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915119932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72111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A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434612173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081815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808526357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855419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365129372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694198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779595409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714974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2611269390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291681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3027130430"/>
                  </a:ext>
                </a:extLst>
              </a:tr>
              <a:tr h="2185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+mn-lt"/>
                        </a:rPr>
                        <a:t>102315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+mn-lt"/>
                        </a:rPr>
                        <a:t>N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065" marR="9065" marT="9065" marB="0" anchor="b"/>
                </a:tc>
                <a:extLst>
                  <a:ext uri="{0D108BD9-81ED-4DB2-BD59-A6C34878D82A}">
                    <a16:rowId xmlns:a16="http://schemas.microsoft.com/office/drawing/2014/main" val="1692957149"/>
                  </a:ext>
                </a:extLst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0197" y="4262350"/>
            <a:ext cx="3990107" cy="234315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0196" y="1227809"/>
            <a:ext cx="3990108" cy="236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9023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3095625" y="985838"/>
            <a:ext cx="6000750" cy="4886325"/>
            <a:chOff x="1571625" y="985837"/>
            <a:chExt cx="6000750" cy="4886325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71625" y="985837"/>
              <a:ext cx="6000750" cy="4886325"/>
            </a:xfrm>
            <a:prstGeom prst="rect">
              <a:avLst/>
            </a:prstGeom>
          </p:spPr>
        </p:pic>
        <p:grpSp>
          <p:nvGrpSpPr>
            <p:cNvPr id="15" name="Group 14"/>
            <p:cNvGrpSpPr/>
            <p:nvPr/>
          </p:nvGrpSpPr>
          <p:grpSpPr>
            <a:xfrm>
              <a:off x="2971800" y="2297723"/>
              <a:ext cx="249115" cy="1424354"/>
              <a:chOff x="2971800" y="2297723"/>
              <a:chExt cx="249115" cy="1424354"/>
            </a:xfrm>
          </p:grpSpPr>
          <p:cxnSp>
            <p:nvCxnSpPr>
              <p:cNvPr id="4" name="Straight Connector 3"/>
              <p:cNvCxnSpPr/>
              <p:nvPr/>
            </p:nvCxnSpPr>
            <p:spPr>
              <a:xfrm>
                <a:off x="2971800" y="3059723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>
                <a:off x="2992315" y="2763716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2974731" y="2579077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2983523" y="2297723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2974731" y="3212123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2992315" y="3431930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2983523" y="3722077"/>
                <a:ext cx="22860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TextBox 1"/>
          <p:cNvSpPr txBox="1"/>
          <p:nvPr/>
        </p:nvSpPr>
        <p:spPr>
          <a:xfrm>
            <a:off x="4698023" y="4114800"/>
            <a:ext cx="3763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051914 TGFb1+ 052314 a-Tubuli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214439" y="2426680"/>
            <a:ext cx="492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217375" y="2623040"/>
            <a:ext cx="492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226158" y="3291257"/>
            <a:ext cx="492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5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8505092" y="3393831"/>
            <a:ext cx="167054" cy="879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8593020" y="3261948"/>
            <a:ext cx="712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GFb1</a:t>
            </a:r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8399585" y="2382716"/>
            <a:ext cx="167054" cy="879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487510" y="2242040"/>
            <a:ext cx="808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-Tubuli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205663" y="3568256"/>
            <a:ext cx="3387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      </a:t>
            </a:r>
            <a:r>
              <a:rPr lang="en-US" dirty="0" err="1"/>
              <a:t>A</a:t>
            </a:r>
            <a:r>
              <a:rPr lang="en-US" dirty="0"/>
              <a:t>      </a:t>
            </a:r>
            <a:r>
              <a:rPr lang="en-US" dirty="0" err="1"/>
              <a:t>A</a:t>
            </a:r>
            <a:r>
              <a:rPr lang="en-US" dirty="0"/>
              <a:t>     </a:t>
            </a:r>
            <a:r>
              <a:rPr lang="en-US" dirty="0" err="1"/>
              <a:t>A</a:t>
            </a:r>
            <a:r>
              <a:rPr lang="en-US" dirty="0"/>
              <a:t>     N      </a:t>
            </a:r>
            <a:r>
              <a:rPr lang="en-US" dirty="0" err="1"/>
              <a:t>N</a:t>
            </a:r>
            <a:r>
              <a:rPr lang="en-US" dirty="0"/>
              <a:t>    </a:t>
            </a:r>
            <a:r>
              <a:rPr lang="en-US" dirty="0" err="1"/>
              <a:t>N</a:t>
            </a:r>
            <a:r>
              <a:rPr lang="en-US" dirty="0"/>
              <a:t>     </a:t>
            </a:r>
            <a:r>
              <a:rPr lang="en-US" dirty="0" err="1"/>
              <a:t>N</a:t>
            </a:r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EA96F98-13E1-4A4F-9D87-3B001909A13C}"/>
              </a:ext>
            </a:extLst>
          </p:cNvPr>
          <p:cNvSpPr/>
          <p:nvPr/>
        </p:nvSpPr>
        <p:spPr>
          <a:xfrm>
            <a:off x="5232050" y="3253533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32DEC60-43F7-45EE-A06C-34C2731CED7B}"/>
              </a:ext>
            </a:extLst>
          </p:cNvPr>
          <p:cNvSpPr txBox="1"/>
          <p:nvPr/>
        </p:nvSpPr>
        <p:spPr>
          <a:xfrm flipH="1">
            <a:off x="5288413" y="2884201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822E65C-C2F0-4A05-9C32-5F5BEC1EAC4E}"/>
              </a:ext>
            </a:extLst>
          </p:cNvPr>
          <p:cNvCxnSpPr/>
          <p:nvPr/>
        </p:nvCxnSpPr>
        <p:spPr>
          <a:xfrm flipH="1">
            <a:off x="8422342" y="2375132"/>
            <a:ext cx="167054" cy="879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>
            <a:extLst>
              <a:ext uri="{FF2B5EF4-FFF2-40B4-BE49-F238E27FC236}">
                <a16:creationId xmlns:a16="http://schemas.microsoft.com/office/drawing/2014/main" id="{4FDB472A-6577-4220-ADB9-6EC5FF2560C5}"/>
              </a:ext>
            </a:extLst>
          </p:cNvPr>
          <p:cNvSpPr/>
          <p:nvPr/>
        </p:nvSpPr>
        <p:spPr>
          <a:xfrm>
            <a:off x="5149300" y="2234834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1A3CFE-5915-43F3-ACDD-AD6709FF31D9}"/>
              </a:ext>
            </a:extLst>
          </p:cNvPr>
          <p:cNvSpPr txBox="1"/>
          <p:nvPr/>
        </p:nvSpPr>
        <p:spPr>
          <a:xfrm flipH="1">
            <a:off x="5205663" y="1865502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</p:spTree>
    <p:extLst>
      <p:ext uri="{BB962C8B-B14F-4D97-AF65-F5344CB8AC3E}">
        <p14:creationId xmlns:p14="http://schemas.microsoft.com/office/powerpoint/2010/main" val="325252259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52401" y="184097"/>
            <a:ext cx="5213684" cy="4339777"/>
            <a:chOff x="2187431" y="954232"/>
            <a:chExt cx="5864225" cy="4873791"/>
          </a:xfrm>
        </p:grpSpPr>
        <p:pic>
          <p:nvPicPr>
            <p:cNvPr id="15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7593" y="3292835"/>
              <a:ext cx="5834063" cy="16525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7431" y="954232"/>
              <a:ext cx="5864225" cy="1590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2512291" y="5458691"/>
              <a:ext cx="46281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0150626  </a:t>
              </a:r>
              <a:r>
                <a:rPr lang="en-US" dirty="0" err="1"/>
                <a:t>Smad</a:t>
              </a:r>
              <a:r>
                <a:rPr lang="en-US" dirty="0"/>
                <a:t> 6 in AVM(8) and normal(8)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5175767" y="586402"/>
            <a:ext cx="7607449" cy="5201372"/>
            <a:chOff x="0" y="672955"/>
            <a:chExt cx="7607449" cy="5201372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672955"/>
              <a:ext cx="7607449" cy="5201372"/>
            </a:xfrm>
            <a:prstGeom prst="rect">
              <a:avLst/>
            </a:prstGeom>
          </p:spPr>
        </p:pic>
        <p:cxnSp>
          <p:nvCxnSpPr>
            <p:cNvPr id="20" name="Straight Arrow Connector 19"/>
            <p:cNvCxnSpPr/>
            <p:nvPr/>
          </p:nvCxnSpPr>
          <p:spPr>
            <a:xfrm flipH="1">
              <a:off x="5441374" y="944448"/>
              <a:ext cx="38792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 flipH="1">
              <a:off x="5442531" y="3004157"/>
              <a:ext cx="38792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 flipH="1">
              <a:off x="3298538" y="5193175"/>
              <a:ext cx="38792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5765806" y="738912"/>
              <a:ext cx="10783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-tubulin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736934" y="2810255"/>
              <a:ext cx="10783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-tubulin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612578" y="4999273"/>
              <a:ext cx="10783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-tubulin</a:t>
              </a:r>
            </a:p>
          </p:txBody>
        </p:sp>
      </p:grpSp>
      <p:sp>
        <p:nvSpPr>
          <p:cNvPr id="26" name="Rectangle 25">
            <a:extLst>
              <a:ext uri="{FF2B5EF4-FFF2-40B4-BE49-F238E27FC236}">
                <a16:creationId xmlns:a16="http://schemas.microsoft.com/office/drawing/2014/main" id="{34ADFFCC-0302-471A-A285-2F9712BFFDA7}"/>
              </a:ext>
            </a:extLst>
          </p:cNvPr>
          <p:cNvSpPr/>
          <p:nvPr/>
        </p:nvSpPr>
        <p:spPr>
          <a:xfrm>
            <a:off x="799981" y="857895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9B9862-8FB9-4326-A3AE-7D3CCA445107}"/>
              </a:ext>
            </a:extLst>
          </p:cNvPr>
          <p:cNvSpPr txBox="1"/>
          <p:nvPr/>
        </p:nvSpPr>
        <p:spPr>
          <a:xfrm flipH="1">
            <a:off x="856344" y="488563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 flipped horizontal in paper</a:t>
            </a:r>
          </a:p>
        </p:txBody>
      </p:sp>
    </p:spTree>
    <p:extLst>
      <p:ext uri="{BB962C8B-B14F-4D97-AF65-F5344CB8AC3E}">
        <p14:creationId xmlns:p14="http://schemas.microsoft.com/office/powerpoint/2010/main" val="273398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4283" y="214298"/>
            <a:ext cx="6143625" cy="420052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6C5C8B24-2624-457F-BBF2-BC8D8351AD7F}"/>
              </a:ext>
            </a:extLst>
          </p:cNvPr>
          <p:cNvSpPr/>
          <p:nvPr/>
        </p:nvSpPr>
        <p:spPr>
          <a:xfrm>
            <a:off x="6808480" y="1530309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EF71C98-603C-4B65-952E-92F27A393B2E}"/>
              </a:ext>
            </a:extLst>
          </p:cNvPr>
          <p:cNvSpPr txBox="1"/>
          <p:nvPr/>
        </p:nvSpPr>
        <p:spPr>
          <a:xfrm flipH="1">
            <a:off x="6864843" y="1160977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 flipped horizontal in paper</a:t>
            </a:r>
          </a:p>
        </p:txBody>
      </p:sp>
    </p:spTree>
    <p:extLst>
      <p:ext uri="{BB962C8B-B14F-4D97-AF65-F5344CB8AC3E}">
        <p14:creationId xmlns:p14="http://schemas.microsoft.com/office/powerpoint/2010/main" val="64434773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85239"/>
            <a:ext cx="4572000" cy="312597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76600" y="4343401"/>
            <a:ext cx="6019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/>
              <a:t>Smad</a:t>
            </a:r>
            <a:r>
              <a:rPr lang="en-US" sz="2400" dirty="0"/>
              <a:t> 8 (1) in AVMs (4) and Normal tissues (4)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3600" y="176003"/>
            <a:ext cx="4602396" cy="31467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22741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801" y="152400"/>
            <a:ext cx="5129213" cy="350695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2600" y="3348182"/>
            <a:ext cx="4996362" cy="341611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05000" y="2209801"/>
            <a:ext cx="2895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/>
              <a:t>Smad</a:t>
            </a:r>
            <a:r>
              <a:rPr lang="en-US" sz="2400" dirty="0"/>
              <a:t> 8 (2) in AVMs (4) and Normal tissues (4) with GAPDH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C41D4FB-0568-40A1-BCF5-493F81C0B23A}"/>
              </a:ext>
            </a:extLst>
          </p:cNvPr>
          <p:cNvSpPr/>
          <p:nvPr/>
        </p:nvSpPr>
        <p:spPr>
          <a:xfrm>
            <a:off x="6387061" y="830594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280732-71F5-4B4A-BBFA-0D45C57800EE}"/>
              </a:ext>
            </a:extLst>
          </p:cNvPr>
          <p:cNvSpPr txBox="1"/>
          <p:nvPr/>
        </p:nvSpPr>
        <p:spPr>
          <a:xfrm flipH="1">
            <a:off x="6443424" y="461262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 flipped horizontal in paper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DA95D77-8DE6-406E-8943-D3FA1B3E3268}"/>
              </a:ext>
            </a:extLst>
          </p:cNvPr>
          <p:cNvSpPr/>
          <p:nvPr/>
        </p:nvSpPr>
        <p:spPr>
          <a:xfrm>
            <a:off x="6569941" y="4113409"/>
            <a:ext cx="2908014" cy="41088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AECAA1-6004-4723-8B12-D880049F2DFE}"/>
              </a:ext>
            </a:extLst>
          </p:cNvPr>
          <p:cNvSpPr txBox="1"/>
          <p:nvPr/>
        </p:nvSpPr>
        <p:spPr>
          <a:xfrm flipH="1">
            <a:off x="6626302" y="3744077"/>
            <a:ext cx="46946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 flipped horizontal in paper (GAPDH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259D8DE-4452-402F-ADAA-4B3CB2DBC2D5}"/>
              </a:ext>
            </a:extLst>
          </p:cNvPr>
          <p:cNvSpPr txBox="1"/>
          <p:nvPr/>
        </p:nvSpPr>
        <p:spPr>
          <a:xfrm>
            <a:off x="8036869" y="1420131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</a:t>
            </a:r>
          </a:p>
        </p:txBody>
      </p:sp>
    </p:spTree>
    <p:extLst>
      <p:ext uri="{BB962C8B-B14F-4D97-AF65-F5344CB8AC3E}">
        <p14:creationId xmlns:p14="http://schemas.microsoft.com/office/powerpoint/2010/main" val="750142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665" y="1286309"/>
            <a:ext cx="5303520" cy="411593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997906" y="332643"/>
            <a:ext cx="17124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GAPDH, 37kd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/>
          </p:nvPr>
        </p:nvGraphicFramePr>
        <p:xfrm>
          <a:off x="7926301" y="924892"/>
          <a:ext cx="1907655" cy="419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0128">
                  <a:extLst>
                    <a:ext uri="{9D8B030D-6E8A-4147-A177-3AD203B41FA5}">
                      <a16:colId xmlns:a16="http://schemas.microsoft.com/office/drawing/2014/main" val="2228007142"/>
                    </a:ext>
                  </a:extLst>
                </a:gridCol>
                <a:gridCol w="997527">
                  <a:extLst>
                    <a:ext uri="{9D8B030D-6E8A-4147-A177-3AD203B41FA5}">
                      <a16:colId xmlns:a16="http://schemas.microsoft.com/office/drawing/2014/main" val="369145003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ample I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ID on Ge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6939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0195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7248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29747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71253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81815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671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91681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9437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0656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60696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416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23200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51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6085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394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9370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7358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31998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101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2182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2510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1993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5422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7376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99685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407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4586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68640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5244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941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81772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613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94206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8922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41273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102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74431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7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5558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58526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900858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344189" y="740226"/>
            <a:ext cx="372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p      N1   N2   N3   N4  N5  A1   A2   A3   A4  A5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989565" y="4233549"/>
            <a:ext cx="40083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Bottom    N6   N7  N8  N9 N10 A6  A7   A8  A9  A10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96B6CCF-B720-4E98-BBD2-FA4DCAA6C66F}"/>
              </a:ext>
            </a:extLst>
          </p:cNvPr>
          <p:cNvSpPr/>
          <p:nvPr/>
        </p:nvSpPr>
        <p:spPr>
          <a:xfrm>
            <a:off x="2631882" y="2821709"/>
            <a:ext cx="3131609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4910CBF-898C-4D36-83AA-C28BE6010888}"/>
              </a:ext>
            </a:extLst>
          </p:cNvPr>
          <p:cNvSpPr txBox="1"/>
          <p:nvPr/>
        </p:nvSpPr>
        <p:spPr>
          <a:xfrm flipH="1">
            <a:off x="3787883" y="2452377"/>
            <a:ext cx="1975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GAPDH Fig 2C</a:t>
            </a:r>
          </a:p>
        </p:txBody>
      </p:sp>
    </p:spTree>
    <p:extLst>
      <p:ext uri="{BB962C8B-B14F-4D97-AF65-F5344CB8AC3E}">
        <p14:creationId xmlns:p14="http://schemas.microsoft.com/office/powerpoint/2010/main" val="40918032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6247649" y="317995"/>
            <a:ext cx="1678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MAD1, 58-60kd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7926301" y="924892"/>
          <a:ext cx="1907655" cy="419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0128">
                  <a:extLst>
                    <a:ext uri="{9D8B030D-6E8A-4147-A177-3AD203B41FA5}">
                      <a16:colId xmlns:a16="http://schemas.microsoft.com/office/drawing/2014/main" val="2228007142"/>
                    </a:ext>
                  </a:extLst>
                </a:gridCol>
                <a:gridCol w="997527">
                  <a:extLst>
                    <a:ext uri="{9D8B030D-6E8A-4147-A177-3AD203B41FA5}">
                      <a16:colId xmlns:a16="http://schemas.microsoft.com/office/drawing/2014/main" val="369145003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ample I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ID on Ge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6939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0195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7248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29747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71253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81815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671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91681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9437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0656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60696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416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23200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51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6085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394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9370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7358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31998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101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2182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2510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1993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5422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7376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99685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407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4586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68640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5244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941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81772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613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94206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8922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41273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102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74431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7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5558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58526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900858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344189" y="740226"/>
            <a:ext cx="372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p      N1   N2   N3   N4  N5  A1   A2   A3   A4  A5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527808" y="5809997"/>
            <a:ext cx="43432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Bottom    N6   N7  N8  N9  N10  A6   A7  A8   A9  A10  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3970" y="1072822"/>
            <a:ext cx="5341478" cy="473700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5FB5894-6E5E-4E31-98B0-D65D18AAD486}"/>
              </a:ext>
            </a:extLst>
          </p:cNvPr>
          <p:cNvSpPr/>
          <p:nvPr/>
        </p:nvSpPr>
        <p:spPr>
          <a:xfrm>
            <a:off x="2695492" y="3667306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62C6AD-9995-4795-97CD-C67762C0AA68}"/>
              </a:ext>
            </a:extLst>
          </p:cNvPr>
          <p:cNvSpPr txBox="1"/>
          <p:nvPr/>
        </p:nvSpPr>
        <p:spPr>
          <a:xfrm flipH="1">
            <a:off x="3915869" y="3244334"/>
            <a:ext cx="1257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</a:t>
            </a:r>
          </a:p>
        </p:txBody>
      </p:sp>
    </p:spTree>
    <p:extLst>
      <p:ext uri="{BB962C8B-B14F-4D97-AF65-F5344CB8AC3E}">
        <p14:creationId xmlns:p14="http://schemas.microsoft.com/office/powerpoint/2010/main" val="14185352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6247649" y="241795"/>
            <a:ext cx="1678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MAD2, 60kd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7926301" y="924892"/>
          <a:ext cx="1907655" cy="419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0128">
                  <a:extLst>
                    <a:ext uri="{9D8B030D-6E8A-4147-A177-3AD203B41FA5}">
                      <a16:colId xmlns:a16="http://schemas.microsoft.com/office/drawing/2014/main" val="2228007142"/>
                    </a:ext>
                  </a:extLst>
                </a:gridCol>
                <a:gridCol w="997527">
                  <a:extLst>
                    <a:ext uri="{9D8B030D-6E8A-4147-A177-3AD203B41FA5}">
                      <a16:colId xmlns:a16="http://schemas.microsoft.com/office/drawing/2014/main" val="369145003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ample I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ID on Ge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6939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0195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7248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829747N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71253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81815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671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91681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9437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0656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60696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416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23200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51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6085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394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9370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7358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31998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101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2182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2510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1993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5422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7376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99685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407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4586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68640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5244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941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81772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613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94206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8922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41273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102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74431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7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5558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58526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900858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344189" y="740226"/>
            <a:ext cx="372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p      N1   N2   N3   N4  N5  A1   A2   A3   A4  A5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082535" y="5710999"/>
            <a:ext cx="43432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Bottom    N6   N7  N8  N9  N10  A6   A7  A8   A9  A10  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680228" y="1090992"/>
            <a:ext cx="5317068" cy="4577018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F487541-6ACE-41B7-BE96-F488D5ADF13C}"/>
              </a:ext>
            </a:extLst>
          </p:cNvPr>
          <p:cNvSpPr/>
          <p:nvPr/>
        </p:nvSpPr>
        <p:spPr>
          <a:xfrm>
            <a:off x="2759102" y="3482640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FD8E13-3E32-4B51-A8A1-6944E287EE59}"/>
              </a:ext>
            </a:extLst>
          </p:cNvPr>
          <p:cNvSpPr txBox="1"/>
          <p:nvPr/>
        </p:nvSpPr>
        <p:spPr>
          <a:xfrm flipH="1">
            <a:off x="3979479" y="3059668"/>
            <a:ext cx="1257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</a:t>
            </a:r>
          </a:p>
        </p:txBody>
      </p:sp>
    </p:spTree>
    <p:extLst>
      <p:ext uri="{BB962C8B-B14F-4D97-AF65-F5344CB8AC3E}">
        <p14:creationId xmlns:p14="http://schemas.microsoft.com/office/powerpoint/2010/main" val="22778152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5266665" y="180731"/>
            <a:ext cx="13237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MAD3, 52k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471090" y="574249"/>
            <a:ext cx="319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1   N2   N3   N4  N5  A1  A2  A3  A4  A5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696993" y="550215"/>
            <a:ext cx="335893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N6   N7  N8  N9  N10  A6   A7  A8  A9  A10 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7208" y="1015146"/>
            <a:ext cx="4874625" cy="473090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3664" y="857992"/>
            <a:ext cx="5024030" cy="4737003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6381032" y="2236124"/>
            <a:ext cx="28263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>
            <a:off x="5311834" y="2236124"/>
            <a:ext cx="3408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717585" y="2051458"/>
            <a:ext cx="645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2kd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6ABE928-444F-42AA-9A1D-9775B26CF617}"/>
              </a:ext>
            </a:extLst>
          </p:cNvPr>
          <p:cNvSpPr/>
          <p:nvPr/>
        </p:nvSpPr>
        <p:spPr>
          <a:xfrm>
            <a:off x="7592877" y="2051458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1E8930-75C4-4CCD-BD37-FDD3351ADAEC}"/>
              </a:ext>
            </a:extLst>
          </p:cNvPr>
          <p:cNvSpPr txBox="1"/>
          <p:nvPr/>
        </p:nvSpPr>
        <p:spPr>
          <a:xfrm flipH="1">
            <a:off x="8813254" y="1628486"/>
            <a:ext cx="1257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</a:t>
            </a:r>
          </a:p>
        </p:txBody>
      </p:sp>
    </p:spTree>
    <p:extLst>
      <p:ext uri="{BB962C8B-B14F-4D97-AF65-F5344CB8AC3E}">
        <p14:creationId xmlns:p14="http://schemas.microsoft.com/office/powerpoint/2010/main" val="15223293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6247649" y="315564"/>
            <a:ext cx="1678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MAD5, 60kd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7926301" y="924892"/>
          <a:ext cx="1907655" cy="4191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0128">
                  <a:extLst>
                    <a:ext uri="{9D8B030D-6E8A-4147-A177-3AD203B41FA5}">
                      <a16:colId xmlns:a16="http://schemas.microsoft.com/office/drawing/2014/main" val="2228007142"/>
                    </a:ext>
                  </a:extLst>
                </a:gridCol>
                <a:gridCol w="997527">
                  <a:extLst>
                    <a:ext uri="{9D8B030D-6E8A-4147-A177-3AD203B41FA5}">
                      <a16:colId xmlns:a16="http://schemas.microsoft.com/office/drawing/2014/main" val="369145003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ample I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ID on Ge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6939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0195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72482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29747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71253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81815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67104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91681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9437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06566N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60696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416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23200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514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6085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394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593700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7358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31998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2101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2182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25101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1993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5422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7376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996856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407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4586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68640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524463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694198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N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81772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613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994206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78922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41273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1020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744317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0713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55584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58526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A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900858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344189" y="740226"/>
            <a:ext cx="372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op      N1   N2   N3   N4  N5  A1   A2   A3   A4  A5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240475" y="5711000"/>
            <a:ext cx="434320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Bottom    N6   N7  N8  N9  N10  A6  A7  A8  A9  A10 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583397" y="1011000"/>
            <a:ext cx="5341477" cy="4737003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498DA884-07A9-4445-8772-015844CF19BA}"/>
              </a:ext>
            </a:extLst>
          </p:cNvPr>
          <p:cNvSpPr/>
          <p:nvPr/>
        </p:nvSpPr>
        <p:spPr>
          <a:xfrm>
            <a:off x="2881495" y="3611647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081C42-0421-4157-9ADA-68C665DE1EF4}"/>
              </a:ext>
            </a:extLst>
          </p:cNvPr>
          <p:cNvSpPr txBox="1"/>
          <p:nvPr/>
        </p:nvSpPr>
        <p:spPr>
          <a:xfrm flipH="1">
            <a:off x="4101872" y="3188675"/>
            <a:ext cx="1257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C</a:t>
            </a:r>
          </a:p>
        </p:txBody>
      </p:sp>
    </p:spTree>
    <p:extLst>
      <p:ext uri="{BB962C8B-B14F-4D97-AF65-F5344CB8AC3E}">
        <p14:creationId xmlns:p14="http://schemas.microsoft.com/office/powerpoint/2010/main" val="42277618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219200"/>
            <a:ext cx="2011680" cy="381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580365"/>
            <a:ext cx="2011680" cy="353196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 flipH="1">
            <a:off x="3535680" y="1409700"/>
            <a:ext cx="328827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733800" y="1625769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GAPDH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3535680" y="1795046"/>
            <a:ext cx="328827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569892" y="1240423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ALK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45608" y="1918172"/>
            <a:ext cx="2187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A         </a:t>
            </a:r>
            <a:r>
              <a:rPr lang="en-US" dirty="0" err="1"/>
              <a:t>A</a:t>
            </a:r>
            <a:r>
              <a:rPr lang="en-US" dirty="0"/>
              <a:t>        N      </a:t>
            </a:r>
            <a:r>
              <a:rPr lang="en-US" dirty="0" err="1"/>
              <a:t>N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7360" y="509336"/>
            <a:ext cx="6143625" cy="420052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20842" y="2537409"/>
            <a:ext cx="6143625" cy="4200525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BA833789-0D4F-4F02-8495-C90DCE03FC32}"/>
              </a:ext>
            </a:extLst>
          </p:cNvPr>
          <p:cNvSpPr/>
          <p:nvPr/>
        </p:nvSpPr>
        <p:spPr>
          <a:xfrm>
            <a:off x="6838122" y="1034533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E2FE95F-3D2A-4288-AF12-2BF97BBAA7A1}"/>
              </a:ext>
            </a:extLst>
          </p:cNvPr>
          <p:cNvSpPr txBox="1"/>
          <p:nvPr/>
        </p:nvSpPr>
        <p:spPr>
          <a:xfrm flipH="1">
            <a:off x="6894486" y="665201"/>
            <a:ext cx="413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</p:spTree>
    <p:extLst>
      <p:ext uri="{BB962C8B-B14F-4D97-AF65-F5344CB8AC3E}">
        <p14:creationId xmlns:p14="http://schemas.microsoft.com/office/powerpoint/2010/main" val="34644606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3912" y="649787"/>
            <a:ext cx="7461335" cy="6052854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4581921" y="759243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585601" y="1015843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4596635" y="1274270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4598458" y="1380579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4585601" y="1591355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4587419" y="1791134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4576380" y="2080724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576380" y="2179697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557985" y="2423466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515652" y="3679876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515652" y="3929146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515652" y="3517672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515652" y="3834755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510131" y="4183911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510131" y="4317709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4493556" y="4616463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4495339" y="4717270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4493556" y="4917049"/>
            <a:ext cx="26492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145296" y="5118453"/>
            <a:ext cx="5945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TGFBR I  </a:t>
            </a:r>
            <a:r>
              <a:rPr lang="en-US" sz="1400" dirty="0" err="1"/>
              <a:t>abcam</a:t>
            </a:r>
            <a:r>
              <a:rPr lang="en-US" sz="1400" dirty="0"/>
              <a:t> ab51871 1:200 20140805 15ug/lane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254827" y="621893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88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346407" y="870750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8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347749" y="1127079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62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362973" y="1251041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9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360912" y="1466012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8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364065" y="1666028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8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194132" y="3379437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5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215700" y="3539049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237268" y="3707959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268793" y="3811782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75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284043" y="4036378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50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295981" y="4188772"/>
            <a:ext cx="50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7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775055" y="870750"/>
            <a:ext cx="647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lacenta 10ug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668956" y="3498920"/>
            <a:ext cx="6470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lacenta 10ug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296075" y="1923901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676105" y="1925444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046178" y="1908392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6475994" y="1900637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264955" y="4358591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606809" y="4371689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000328" y="4371689"/>
            <a:ext cx="4393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360038" y="4362962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821589" y="1906376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7131838" y="1900495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7551762" y="1900636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7931785" y="1900637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6730516" y="4358147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141619" y="4358590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7479117" y="4353727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7844128" y="4362960"/>
            <a:ext cx="254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913841" y="630810"/>
            <a:ext cx="209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Q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018625" y="3095341"/>
            <a:ext cx="209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325853" y="1589122"/>
            <a:ext cx="6657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GAPDH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8098650" y="3972903"/>
            <a:ext cx="6657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GAPDH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8187960" y="1339092"/>
            <a:ext cx="1044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LK5(TGFBR1)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8098650" y="3777875"/>
            <a:ext cx="1044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LK5(TGFBR1)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36D58ABA-A1EF-4371-98B1-FFC3E878B86E}"/>
              </a:ext>
            </a:extLst>
          </p:cNvPr>
          <p:cNvSpPr/>
          <p:nvPr/>
        </p:nvSpPr>
        <p:spPr>
          <a:xfrm>
            <a:off x="5197440" y="1176826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567AB2-86D6-407A-93AA-C8685D298650}"/>
              </a:ext>
            </a:extLst>
          </p:cNvPr>
          <p:cNvSpPr txBox="1"/>
          <p:nvPr/>
        </p:nvSpPr>
        <p:spPr>
          <a:xfrm flipH="1">
            <a:off x="5253804" y="807494"/>
            <a:ext cx="413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5EE7ACAD-DFE2-4912-85F9-03BA8C3C7F30}"/>
              </a:ext>
            </a:extLst>
          </p:cNvPr>
          <p:cNvSpPr/>
          <p:nvPr/>
        </p:nvSpPr>
        <p:spPr>
          <a:xfrm>
            <a:off x="5151059" y="1559808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8982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3917" y="85475"/>
            <a:ext cx="5470105" cy="37400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9607" y="2192095"/>
            <a:ext cx="6143625" cy="420052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03A46FF-1036-425A-98EE-9AFE900BCB42}"/>
              </a:ext>
            </a:extLst>
          </p:cNvPr>
          <p:cNvSpPr/>
          <p:nvPr/>
        </p:nvSpPr>
        <p:spPr>
          <a:xfrm>
            <a:off x="1329851" y="1034533"/>
            <a:ext cx="3214505" cy="3693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A7D254-0F38-4027-8618-58A43B853651}"/>
              </a:ext>
            </a:extLst>
          </p:cNvPr>
          <p:cNvSpPr txBox="1"/>
          <p:nvPr/>
        </p:nvSpPr>
        <p:spPr>
          <a:xfrm flipH="1">
            <a:off x="1386215" y="665201"/>
            <a:ext cx="4133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40CC0FA-59DA-4D04-8E21-D6916879C910}"/>
              </a:ext>
            </a:extLst>
          </p:cNvPr>
          <p:cNvSpPr/>
          <p:nvPr/>
        </p:nvSpPr>
        <p:spPr>
          <a:xfrm>
            <a:off x="7643367" y="3033105"/>
            <a:ext cx="3345336" cy="39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F5A26F-F5E4-4D3F-81F5-3E831E3AB4E3}"/>
              </a:ext>
            </a:extLst>
          </p:cNvPr>
          <p:cNvSpPr txBox="1"/>
          <p:nvPr/>
        </p:nvSpPr>
        <p:spPr>
          <a:xfrm flipH="1">
            <a:off x="7699730" y="2663773"/>
            <a:ext cx="4301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ig 2A flipped horizontal in paper</a:t>
            </a:r>
          </a:p>
        </p:txBody>
      </p:sp>
    </p:spTree>
    <p:extLst>
      <p:ext uri="{BB962C8B-B14F-4D97-AF65-F5344CB8AC3E}">
        <p14:creationId xmlns:p14="http://schemas.microsoft.com/office/powerpoint/2010/main" val="398793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4</TotalTime>
  <Words>582</Words>
  <Application>Microsoft Office PowerPoint</Application>
  <PresentationFormat>Widescreen</PresentationFormat>
  <Paragraphs>30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Haihong</dc:creator>
  <cp:lastModifiedBy>Strub, Graham</cp:lastModifiedBy>
  <cp:revision>36</cp:revision>
  <dcterms:created xsi:type="dcterms:W3CDTF">2022-03-28T17:21:04Z</dcterms:created>
  <dcterms:modified xsi:type="dcterms:W3CDTF">2022-09-02T15:00:23Z</dcterms:modified>
</cp:coreProperties>
</file>